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-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5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870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2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978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44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96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25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06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74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518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550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35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oncomintan drug (POD ≧31)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7387" y="2771775"/>
            <a:ext cx="5229225" cy="408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972000" y="353271"/>
            <a:ext cx="7200000" cy="1764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</a:t>
            </a:r>
            <a:r>
              <a:rPr lang="en-US" altLang="ja-JP" kern="10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le 3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ltiple comparison of delta AUC between five groups classified according to concomitant drug usage (POD </a:t>
            </a:r>
            <a:r>
              <a:rPr lang="en-US" altLang="ja-JP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31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285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U</dc:creator>
  <cp:lastModifiedBy>Balindan, Danica Joy</cp:lastModifiedBy>
  <cp:revision>3</cp:revision>
  <dcterms:created xsi:type="dcterms:W3CDTF">2017-01-05T06:51:16Z</dcterms:created>
  <dcterms:modified xsi:type="dcterms:W3CDTF">2017-06-19T14:45:59Z</dcterms:modified>
</cp:coreProperties>
</file>